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0" r:id="rId2"/>
  </p:sldIdLst>
  <p:sldSz cx="9144000" cy="6858000" type="screen4x3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YOSHIBA SATOSHI / 吉柴 聡史" initials="SY" lastIdx="2" clrIdx="0"/>
  <p:cmAuthor id="1" name="TAKITA ATSUSHI / 瀧田 厚" initials="A.T." lastIdx="6" clrIdx="1"/>
  <p:cmAuthor id="2" name="SHIRAI TOSHIAKI / 白井 利明" initials="ST/白井" lastIdx="5" clrIdx="2"/>
  <p:cmAuthor id="3" name="Mary Shibuya" initials="MS" lastIdx="1" clrIdx="3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CC"/>
    <a:srgbClr val="FFFF99"/>
    <a:srgbClr val="C1EFFF"/>
    <a:srgbClr val="C5FFD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676" autoAdjust="0"/>
    <p:restoredTop sz="94604" autoAdjust="0"/>
  </p:normalViewPr>
  <p:slideViewPr>
    <p:cSldViewPr snapToGrid="0">
      <p:cViewPr>
        <p:scale>
          <a:sx n="76" d="100"/>
          <a:sy n="76" d="100"/>
        </p:scale>
        <p:origin x="-1284" y="-4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8/4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8/4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8/4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8/4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8/4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8/4/27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8/4/27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8/4/27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8/4/27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8/4/27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8/4/27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pPr/>
              <a:t>2018/4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1049867" y="2947460"/>
            <a:ext cx="2401200" cy="49953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opidogrel</a:t>
            </a:r>
            <a:r>
              <a:rPr kumimoji="1" lang="en-US" altLang="ja-JP" sz="16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75 mg/day</a:t>
            </a:r>
            <a:endParaRPr kumimoji="1" lang="ja-JP" altLang="en-US" sz="16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正方形/長方形 4"/>
          <p:cNvSpPr/>
          <p:nvPr/>
        </p:nvSpPr>
        <p:spPr>
          <a:xfrm>
            <a:off x="3445933" y="2443693"/>
            <a:ext cx="2401200" cy="499533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asugrel</a:t>
            </a:r>
            <a:r>
              <a:rPr kumimoji="1" lang="en-US" altLang="ja-JP" sz="16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3.75 mg/day</a:t>
            </a:r>
            <a:endParaRPr kumimoji="1" lang="ja-JP" altLang="en-US" sz="16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正方形/長方形 5"/>
          <p:cNvSpPr/>
          <p:nvPr/>
        </p:nvSpPr>
        <p:spPr>
          <a:xfrm>
            <a:off x="3445933" y="3451227"/>
            <a:ext cx="2401200" cy="49953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asugrel</a:t>
            </a:r>
            <a:r>
              <a:rPr lang="en-US" altLang="ja-JP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2.5 mg/day</a:t>
            </a:r>
            <a:endParaRPr lang="ja-JP" altLang="en-US" sz="16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正方形/長方形 6"/>
          <p:cNvSpPr/>
          <p:nvPr/>
        </p:nvSpPr>
        <p:spPr>
          <a:xfrm>
            <a:off x="5850455" y="2443693"/>
            <a:ext cx="2401200" cy="4995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asugrel</a:t>
            </a:r>
            <a:r>
              <a:rPr kumimoji="1" lang="en-US" altLang="ja-JP" sz="16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2.5 mg/day</a:t>
            </a:r>
            <a:endParaRPr kumimoji="1" lang="ja-JP" altLang="en-US" sz="16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5850455" y="3451227"/>
            <a:ext cx="2401200" cy="499533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asugrel</a:t>
            </a:r>
            <a:r>
              <a:rPr lang="en-US" altLang="ja-JP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3.75 mg/day</a:t>
            </a:r>
            <a:endParaRPr lang="ja-JP" altLang="en-US" sz="16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1030816" y="1656293"/>
            <a:ext cx="2379133" cy="3077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kumimoji="1" lang="en-US" altLang="ja-JP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Pretreatment period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4080933" y="1656293"/>
            <a:ext cx="990600" cy="3077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kumimoji="1" lang="en-US" altLang="ja-JP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Period 1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6544734" y="1656293"/>
            <a:ext cx="990600" cy="3077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kumimoji="1" lang="en-US" altLang="ja-JP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Period 2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0" name="グループ化 19"/>
          <p:cNvGrpSpPr/>
          <p:nvPr/>
        </p:nvGrpSpPr>
        <p:grpSpPr>
          <a:xfrm>
            <a:off x="1037696" y="1833563"/>
            <a:ext cx="7196661" cy="285750"/>
            <a:chOff x="1037696" y="1633538"/>
            <a:chExt cx="7196661" cy="285750"/>
          </a:xfrm>
        </p:grpSpPr>
        <p:cxnSp>
          <p:nvCxnSpPr>
            <p:cNvPr id="10" name="直線コネクタ 9"/>
            <p:cNvCxnSpPr/>
            <p:nvPr/>
          </p:nvCxnSpPr>
          <p:spPr>
            <a:xfrm>
              <a:off x="1037696" y="1809219"/>
              <a:ext cx="71882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直線コネクタ 14"/>
            <p:cNvCxnSpPr/>
            <p:nvPr/>
          </p:nvCxnSpPr>
          <p:spPr>
            <a:xfrm>
              <a:off x="3452814" y="1814513"/>
              <a:ext cx="0" cy="104775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直線コネクタ 15"/>
            <p:cNvCxnSpPr/>
            <p:nvPr/>
          </p:nvCxnSpPr>
          <p:spPr>
            <a:xfrm>
              <a:off x="5857876" y="1814513"/>
              <a:ext cx="0" cy="104775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直線コネクタ 16"/>
            <p:cNvCxnSpPr/>
            <p:nvPr/>
          </p:nvCxnSpPr>
          <p:spPr>
            <a:xfrm>
              <a:off x="8234357" y="1633538"/>
              <a:ext cx="0" cy="28575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1" name="テキスト ボックス 20"/>
          <p:cNvSpPr txBox="1"/>
          <p:nvPr/>
        </p:nvSpPr>
        <p:spPr>
          <a:xfrm>
            <a:off x="2324101" y="2561061"/>
            <a:ext cx="1082040" cy="3077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kumimoji="1" lang="en-US" altLang="ja-JP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Group A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2324101" y="3591773"/>
            <a:ext cx="1082040" cy="3077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kumimoji="1" lang="en-US" altLang="ja-JP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Group B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636693" y="4109933"/>
            <a:ext cx="3805767" cy="276999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kumimoji="1" lang="en-US" altLang="ja-JP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harmacodynamic</a:t>
            </a:r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 observation point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0" name="グループ化 29"/>
          <p:cNvGrpSpPr/>
          <p:nvPr/>
        </p:nvGrpSpPr>
        <p:grpSpPr>
          <a:xfrm>
            <a:off x="1970193" y="4788113"/>
            <a:ext cx="6533727" cy="307777"/>
            <a:chOff x="1970193" y="4588088"/>
            <a:chExt cx="6533727" cy="307777"/>
          </a:xfrm>
        </p:grpSpPr>
        <p:sp>
          <p:nvSpPr>
            <p:cNvPr id="24" name="テキスト ボックス 23"/>
            <p:cNvSpPr txBox="1"/>
            <p:nvPr/>
          </p:nvSpPr>
          <p:spPr>
            <a:xfrm>
              <a:off x="1970193" y="4588088"/>
              <a:ext cx="529167" cy="307777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kumimoji="1" lang="en-US" altLang="ja-JP" sz="2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2w</a:t>
              </a:r>
              <a:endParaRPr kumimoji="1" lang="ja-JP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テキスト ボックス 24"/>
            <p:cNvSpPr txBox="1"/>
            <p:nvPr/>
          </p:nvSpPr>
          <p:spPr>
            <a:xfrm>
              <a:off x="3235113" y="4588088"/>
              <a:ext cx="529167" cy="307777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kumimoji="1" lang="en-US" altLang="ja-JP" sz="2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w</a:t>
              </a:r>
              <a:endParaRPr kumimoji="1" lang="ja-JP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テキスト ボックス 25"/>
            <p:cNvSpPr txBox="1"/>
            <p:nvPr/>
          </p:nvSpPr>
          <p:spPr>
            <a:xfrm>
              <a:off x="4400973" y="4588088"/>
              <a:ext cx="529167" cy="307777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kumimoji="1" lang="en-US" altLang="ja-JP" sz="2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w</a:t>
              </a:r>
              <a:endParaRPr kumimoji="1" lang="ja-JP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テキスト ボックス 26"/>
            <p:cNvSpPr txBox="1"/>
            <p:nvPr/>
          </p:nvSpPr>
          <p:spPr>
            <a:xfrm>
              <a:off x="5604933" y="4588088"/>
              <a:ext cx="529167" cy="307777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kumimoji="1" lang="en-US" altLang="ja-JP" sz="2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w</a:t>
              </a:r>
              <a:endParaRPr kumimoji="1" lang="ja-JP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テキスト ボックス 27"/>
            <p:cNvSpPr txBox="1"/>
            <p:nvPr/>
          </p:nvSpPr>
          <p:spPr>
            <a:xfrm>
              <a:off x="6793653" y="4588088"/>
              <a:ext cx="529167" cy="307777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kumimoji="1" lang="en-US" altLang="ja-JP" sz="2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w</a:t>
              </a:r>
              <a:endParaRPr kumimoji="1" lang="ja-JP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テキスト ボックス 28"/>
            <p:cNvSpPr txBox="1"/>
            <p:nvPr/>
          </p:nvSpPr>
          <p:spPr>
            <a:xfrm>
              <a:off x="7974753" y="4588088"/>
              <a:ext cx="529167" cy="307777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kumimoji="1" lang="en-US" altLang="ja-JP" sz="2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w</a:t>
              </a:r>
              <a:endParaRPr kumimoji="1" lang="ja-JP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1" name="グループ化 40"/>
          <p:cNvGrpSpPr/>
          <p:nvPr/>
        </p:nvGrpSpPr>
        <p:grpSpPr>
          <a:xfrm>
            <a:off x="1037696" y="4485323"/>
            <a:ext cx="7196661" cy="285750"/>
            <a:chOff x="1037696" y="4285298"/>
            <a:chExt cx="7196661" cy="285750"/>
          </a:xfrm>
        </p:grpSpPr>
        <p:cxnSp>
          <p:nvCxnSpPr>
            <p:cNvPr id="32" name="直線コネクタ 31"/>
            <p:cNvCxnSpPr/>
            <p:nvPr/>
          </p:nvCxnSpPr>
          <p:spPr>
            <a:xfrm>
              <a:off x="1037696" y="4460979"/>
              <a:ext cx="71882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直線コネクタ 34"/>
            <p:cNvCxnSpPr/>
            <p:nvPr/>
          </p:nvCxnSpPr>
          <p:spPr>
            <a:xfrm>
              <a:off x="8234357" y="4285298"/>
              <a:ext cx="0" cy="28575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線コネクタ 35"/>
            <p:cNvCxnSpPr/>
            <p:nvPr/>
          </p:nvCxnSpPr>
          <p:spPr>
            <a:xfrm>
              <a:off x="2245037" y="4285298"/>
              <a:ext cx="0" cy="28575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直線コネクタ 36"/>
            <p:cNvCxnSpPr/>
            <p:nvPr/>
          </p:nvCxnSpPr>
          <p:spPr>
            <a:xfrm>
              <a:off x="5838629" y="4285298"/>
              <a:ext cx="0" cy="28575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直線コネクタ 37"/>
            <p:cNvCxnSpPr/>
            <p:nvPr/>
          </p:nvCxnSpPr>
          <p:spPr>
            <a:xfrm>
              <a:off x="3442901" y="4285298"/>
              <a:ext cx="0" cy="28575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直線コネクタ 38"/>
            <p:cNvCxnSpPr/>
            <p:nvPr/>
          </p:nvCxnSpPr>
          <p:spPr>
            <a:xfrm>
              <a:off x="4640765" y="4285298"/>
              <a:ext cx="0" cy="28575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直線コネクタ 39"/>
            <p:cNvCxnSpPr/>
            <p:nvPr/>
          </p:nvCxnSpPr>
          <p:spPr>
            <a:xfrm>
              <a:off x="7036493" y="4285298"/>
              <a:ext cx="0" cy="28575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3" name="テキスト ボックス 32"/>
          <p:cNvSpPr txBox="1"/>
          <p:nvPr/>
        </p:nvSpPr>
        <p:spPr>
          <a:xfrm>
            <a:off x="773463" y="200462"/>
            <a:ext cx="23775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984858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49</TotalTime>
  <Words>37</Words>
  <Application>Microsoft Office PowerPoint</Application>
  <PresentationFormat>画面に合わせる (4:3)</PresentationFormat>
  <Paragraphs>18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IRAI TOSHIAKI / 白井 利明</dc:creator>
  <cp:lastModifiedBy>RI</cp:lastModifiedBy>
  <cp:revision>25</cp:revision>
  <cp:lastPrinted>2017-06-19T08:27:10Z</cp:lastPrinted>
  <dcterms:created xsi:type="dcterms:W3CDTF">2016-01-11T05:00:31Z</dcterms:created>
  <dcterms:modified xsi:type="dcterms:W3CDTF">2018-04-27T07:04:17Z</dcterms:modified>
</cp:coreProperties>
</file>